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7" r:id="rId2"/>
    <p:sldId id="258" r:id="rId3"/>
    <p:sldId id="259" r:id="rId4"/>
    <p:sldId id="260" r:id="rId5"/>
    <p:sldId id="263" r:id="rId6"/>
    <p:sldId id="261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77778" autoAdjust="0"/>
  </p:normalViewPr>
  <p:slideViewPr>
    <p:cSldViewPr snapToGrid="0">
      <p:cViewPr varScale="1">
        <p:scale>
          <a:sx n="49" d="100"/>
          <a:sy n="49" d="100"/>
        </p:scale>
        <p:origin x="1336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D7C3F0-E9BE-49AB-BE9A-7B60E918EDF5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DE4508-3F51-4DC5-A349-D5728EE72B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98253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g123e9aacdc9_0_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93" name="Google Shape;93;g123e9aacdc9_0_1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Image by Flamingo Images, retrieved from: https://thenounproject.com/photo/portrait-of-girl-looking-down-in-jean-overalls-49W8y0/ on 3 September 2022. Creative Commons License associated: NounProject.com.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Studio Portrait Of Girl Looking Down In Jean Overalls by Flamingo Images from NounProject.com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u="sng">
                <a:effectLst/>
              </a:rPr>
              <a:t>Creative Commons License (CC BY-NC-ND 2.0)</a:t>
            </a:r>
            <a:endParaRPr lang="en-US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lang="en-US"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This slide should be shown on a screen or handed to the learners upon commencement of the simulation.</a:t>
            </a:r>
            <a:endParaRPr dirty="0"/>
          </a:p>
        </p:txBody>
      </p:sp>
      <p:sp>
        <p:nvSpPr>
          <p:cNvPr id="94" name="Google Shape;94;g123e9aacdc9_0_12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00"/>
          </a:xfrm>
          <a:prstGeom prst="rect">
            <a:avLst/>
          </a:prstGeom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buNone/>
            </a:pPr>
            <a:fld id="{00000000-1234-1234-1234-123412341234}" type="slidenum">
              <a:rPr lang="en-US"/>
              <a:t>1</a:t>
            </a:fld>
            <a:endParaRPr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g123e9aacdc9_0_1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1" name="Google Shape;101;g123e9aacdc9_0_1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Instructors should present this slide if the learners request results of a complete blood count (CBC)</a:t>
            </a:r>
            <a:endParaRPr dirty="0"/>
          </a:p>
        </p:txBody>
      </p:sp>
      <p:sp>
        <p:nvSpPr>
          <p:cNvPr id="102" name="Google Shape;102;g123e9aacdc9_0_18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00"/>
          </a:xfrm>
          <a:prstGeom prst="rect">
            <a:avLst/>
          </a:prstGeom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buNone/>
            </a:pPr>
            <a:fld id="{00000000-1234-1234-1234-123412341234}" type="slidenum">
              <a:rPr lang="en-US"/>
              <a:t>2</a:t>
            </a:fld>
            <a:endParaRPr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Google Shape;106;g11b19981c3f_1_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07" name="Google Shape;107;g11b19981c3f_1_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dirty="0"/>
              <a:t>Instructors should present this slide if the learners request results of a reticulocyte count and/or a Coronavirus rapid test.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08" name="Google Shape;108;g11b19981c3f_1_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00"/>
          </a:xfrm>
          <a:prstGeom prst="rect">
            <a:avLst/>
          </a:prstGeom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buNone/>
            </a:pPr>
            <a:fld id="{00000000-1234-1234-1234-123412341234}" type="slidenum">
              <a:rPr lang="en-US"/>
              <a:t>3</a:t>
            </a:fld>
            <a:endParaRPr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Google Shape;114;g123e9aacdc9_0_2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15" name="Google Shape;115;g123e9aacdc9_0_2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Instructors should present this slide if the learners request results of a basic metabolic profile (BMP), complete/comprehensive metabolic profile (CMP), liver function panel (LFTs), metabolic panel, or electrolyte panel.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16" name="Google Shape;116;g123e9aacdc9_0_28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00"/>
          </a:xfrm>
          <a:prstGeom prst="rect">
            <a:avLst/>
          </a:prstGeom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buNone/>
            </a:pPr>
            <a:fld id="{00000000-1234-1234-1234-123412341234}" type="slidenum">
              <a:rPr lang="en-US"/>
              <a:t>4</a:t>
            </a:fld>
            <a:endParaRPr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Instructors should present this slide if the learners request results of an erythrocyte sedimentation rate (ESR), or a c-reactive protein (CRP)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DE4508-3F51-4DC5-A349-D5728EE72B64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04065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Google Shape;120;g11b19981c3f_1_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1" name="Google Shape;121;g11b19981c3f_1_1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Instructors should present this slide if the learners request results of a urinalysis (UA).</a:t>
            </a: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22" name="Google Shape;122;g11b19981c3f_1_10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00"/>
          </a:xfrm>
          <a:prstGeom prst="rect">
            <a:avLst/>
          </a:prstGeom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buNone/>
            </a:pPr>
            <a:fld id="{00000000-1234-1234-1234-123412341234}" type="slidenum">
              <a:rPr lang="en-US"/>
              <a:t>6</a:t>
            </a:fld>
            <a:endParaRPr/>
          </a:p>
        </p:txBody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Google Shape;126;g123e9aacdc9_0_4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127" name="Google Shape;127;g123e9aacdc9_0_4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6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Instructors should present this slide if the learners request to see an elbow radiograph (x-ray) or the results of an elbow x-ray. They are not expected to interpret a radiographic image.</a:t>
            </a:r>
          </a:p>
        </p:txBody>
      </p:sp>
      <p:sp>
        <p:nvSpPr>
          <p:cNvPr id="128" name="Google Shape;128;g123e9aacdc9_0_42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00"/>
          </a:xfrm>
          <a:prstGeom prst="rect">
            <a:avLst/>
          </a:prstGeom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Font typeface="Arial"/>
              <a:buNone/>
            </a:pPr>
            <a:fld id="{00000000-1234-1234-1234-123412341234}" type="slidenum">
              <a:rPr lang="en-US"/>
              <a:t>7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B5B65C-5B53-C2BB-73F0-1F6E0D53DA3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B009581-6748-8A3C-D20D-F603E99114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39A667-6D6B-1DE7-0765-3B66D94D2C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5076-747E-44AA-9609-BD186FDA6C83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B14194-5F07-79A0-6CA3-FA3C039C3D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A3ABF4-098D-58B2-0550-E8EBCDCD00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D4A30-D115-46E7-8BA4-5A78029467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849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C3C775-5ADC-1BDC-353E-79A606922C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B94BA5-5431-88E6-334F-62B2800A01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71DBE9-F9DB-976F-05C8-9D0981021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5076-747E-44AA-9609-BD186FDA6C83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DE5848-CC53-496D-2B60-D494D389BF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9F3645-0B72-B4C6-6157-ECFA8C2A6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D4A30-D115-46E7-8BA4-5A78029467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00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448D6DA-DB01-4991-3B16-ABEB8AAD0D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B4A198-6124-9716-8316-318F5366FD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C087B1-065C-8434-A365-E4371B05D9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5076-747E-44AA-9609-BD186FDA6C83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D69378-F54B-F8CF-BA2D-D856F21FAE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00E581-C2F7-AE4E-074F-1DDDF7BF08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D4A30-D115-46E7-8BA4-5A78029467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3543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EE2864-2F7D-7F35-0153-60A12E32F1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1925D3-C951-1430-A557-1D99E38878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1FDE85-FF77-765B-EDB5-61A17C13B5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5076-747E-44AA-9609-BD186FDA6C83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3C6775-050D-040F-AF60-33D2EFBCEF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07C08E-478C-B613-10E3-547113E9B6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D4A30-D115-46E7-8BA4-5A78029467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3022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AAB38D-8D24-2CF9-B0E5-8CF701934C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07F819-FE87-1C9F-0946-ACD71696B9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E07FC5-BBDF-6B23-8F20-AEEC1D5D6E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5076-747E-44AA-9609-BD186FDA6C83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4745A7-1AE1-E452-0B3F-CA19F83A40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4D23D5-FDD3-A784-A74A-469A298B33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D4A30-D115-46E7-8BA4-5A78029467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97559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BE6E92-9052-31E1-076C-89FFA9A034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48D79B2-6424-3C71-AC7A-4604D7DDF7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3E414EE-12D5-F6A4-5D2E-F6B7D86817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AA992B-D478-9C99-703D-4AD3C3C30A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5076-747E-44AA-9609-BD186FDA6C83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55FB70-DC96-ACE5-339C-96C0FCEF4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CA922A-6C89-5770-DE21-D251F985E5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D4A30-D115-46E7-8BA4-5A78029467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852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FB0A95-2EDE-E401-F055-89AD94024C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5ABADD-2FAB-56E9-871C-BBD790933B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B5E9639-CC45-8526-E87D-DBB94D7B03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0E746F3-B38E-9BD5-6C66-1C73CEEB97E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3184A9C-DE4E-87F4-EECE-741AEB0747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F58E738-FC20-708F-521E-D3993F23F4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5076-747E-44AA-9609-BD186FDA6C83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4B6DDCD-8594-3DEC-2D81-A03D34656B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7604643-D751-ACEA-8EEE-17DDA565DF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D4A30-D115-46E7-8BA4-5A78029467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025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028F1A-D598-A797-991C-7D46D56FA0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E30B600-1349-E28C-CF0C-D4250A38E1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5076-747E-44AA-9609-BD186FDA6C83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BF01B97-6D82-C424-2A5E-AA0DD2FE5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CB92AB1-A043-667C-0DDB-A5C0F3D97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D4A30-D115-46E7-8BA4-5A78029467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9769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5B3435C-02E8-3B49-46A8-90F097D789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5076-747E-44AA-9609-BD186FDA6C83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0326679-6E40-96AE-1FF3-F675DDA3F3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E1DE9E4-1A3D-66DA-5D51-CB4E024707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D4A30-D115-46E7-8BA4-5A78029467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75510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44E7E2-DCB5-B690-129B-DE6AE30E9C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965866-66DF-992B-BC4F-F18522D37D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AB00BD9-FB3E-FC67-AD6D-BC2C9F1A40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61E33B-C178-50CB-53E1-12F446C30B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5076-747E-44AA-9609-BD186FDA6C83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47FDB2-5944-E998-3ED0-131697178E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E41B64-DE81-6787-E9B7-7BABD3FFBB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D4A30-D115-46E7-8BA4-5A78029467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6056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9F8847-C3A6-5BDA-6CCD-0702C0E693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FE76992-684E-9251-266F-0742D6459A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6E547B-E29F-BFA2-B348-1E219EC63F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60AD08-1213-F07C-4E84-316CFE7EF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C45076-747E-44AA-9609-BD186FDA6C83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F5938A-707A-C9AB-3E18-19D5A21162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065EBC-A93F-C522-5CFF-3676156B9A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D4A30-D115-46E7-8BA4-5A78029467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00782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3D148EC-B8FE-D0F6-640E-8F3E12520F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450E723-A9A1-5EC4-1C6D-2CA4D82074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CCBB04-443C-4D7F-D6D0-84309DBC98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C45076-747E-44AA-9609-BD186FDA6C83}" type="datetimeFigureOut">
              <a:rPr lang="en-US" smtClean="0"/>
              <a:t>1/1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A4FFE1-7A4A-9A68-2BE4-39D59F3755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A193FA-6650-C624-9AB2-07CAC7BB9F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9D4A30-D115-46E7-8BA4-5A78029467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306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06" name="Rectangle 101">
            <a:extLst>
              <a:ext uri="{FF2B5EF4-FFF2-40B4-BE49-F238E27FC236}">
                <a16:creationId xmlns:a16="http://schemas.microsoft.com/office/drawing/2014/main" id="{7D9D36D6-2AC5-46A1-A849-4C82D5264A3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96" name="Google Shape;96;g123e9aacdc9_0_12"/>
          <p:cNvSpPr txBox="1">
            <a:spLocks noGrp="1"/>
          </p:cNvSpPr>
          <p:nvPr>
            <p:ph type="title"/>
          </p:nvPr>
        </p:nvSpPr>
        <p:spPr>
          <a:xfrm>
            <a:off x="5354955" y="552182"/>
            <a:ext cx="5998840" cy="3343135"/>
          </a:xfrm>
          <a:prstGeom prst="rect">
            <a:avLst/>
          </a:prstGeom>
          <a:noFill/>
        </p:spPr>
        <p:txBody>
          <a:bodyPr spcFirstLastPara="1" vert="horz" lIns="91440" tIns="45720" rIns="91440" bIns="45720" rtlCol="0" anchor="b" anchorCtr="0">
            <a:normAutofit/>
          </a:bodyPr>
          <a:lstStyle/>
          <a:p>
            <a:pPr marL="0" lvl="0" indent="0">
              <a:spcAft>
                <a:spcPts val="0"/>
              </a:spcAft>
            </a:pPr>
            <a:r>
              <a:rPr lang="en-US" sz="5200"/>
              <a:t>Chief Complaint</a:t>
            </a:r>
          </a:p>
        </p:txBody>
      </p:sp>
      <p:sp>
        <p:nvSpPr>
          <p:cNvPr id="97" name="Google Shape;97;g123e9aacdc9_0_12"/>
          <p:cNvSpPr txBox="1">
            <a:spLocks noGrp="1"/>
          </p:cNvSpPr>
          <p:nvPr>
            <p:ph type="body" idx="1"/>
          </p:nvPr>
        </p:nvSpPr>
        <p:spPr>
          <a:xfrm>
            <a:off x="5354955" y="4067032"/>
            <a:ext cx="5998840" cy="2067068"/>
          </a:xfrm>
          <a:prstGeom prst="rect">
            <a:avLst/>
          </a:prstGeom>
          <a:noFill/>
        </p:spPr>
        <p:txBody>
          <a:bodyPr spcFirstLastPara="1" vert="horz" lIns="91440" tIns="45720" rIns="91440" bIns="45720" rtlCol="0" anchorCtr="0">
            <a:normAutofit/>
          </a:bodyPr>
          <a:lstStyle/>
          <a:p>
            <a:pPr marL="0" lvl="0" indent="0">
              <a:spcAft>
                <a:spcPts val="0"/>
              </a:spcAft>
              <a:buNone/>
            </a:pPr>
            <a:r>
              <a:rPr lang="en-US" sz="2400"/>
              <a:t>9-year-old girl presents with pain and fever.</a:t>
            </a:r>
          </a:p>
        </p:txBody>
      </p:sp>
      <p:pic>
        <p:nvPicPr>
          <p:cNvPr id="8" name="Picture 7" descr="A picture containing text, person, hairpiece&#10;&#10;Description automatically generated">
            <a:extLst>
              <a:ext uri="{FF2B5EF4-FFF2-40B4-BE49-F238E27FC236}">
                <a16:creationId xmlns:a16="http://schemas.microsoft.com/office/drawing/2014/main" id="{53E30286-D987-05DB-62C3-AE285535F4D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69"/>
          <a:stretch/>
        </p:blipFill>
        <p:spPr>
          <a:xfrm>
            <a:off x="20" y="10"/>
            <a:ext cx="4992985" cy="685799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1393979-2A51-C6B2-EB87-BA66A50A9DD6}"/>
              </a:ext>
            </a:extLst>
          </p:cNvPr>
          <p:cNvSpPr txBox="1"/>
          <p:nvPr/>
        </p:nvSpPr>
        <p:spPr>
          <a:xfrm>
            <a:off x="4932589" y="6678703"/>
            <a:ext cx="7421282" cy="1923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650" dirty="0">
                <a:solidFill>
                  <a:schemeClr val="bg2">
                    <a:lumMod val="90000"/>
                  </a:schemeClr>
                </a:solidFill>
              </a:rPr>
              <a:t>Image by Flamingo Images, retrieved from: https://thenounproject.com/photo/portrait-of-girl-looking-down-in-jean-overalls-49W8y0/ on 3 September 2022. Creative Commons License associated: NounProject.com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4" name="Google Shape;104;g123e9aacdc9_0_18"/>
          <p:cNvGraphicFramePr/>
          <p:nvPr>
            <p:extLst>
              <p:ext uri="{D42A27DB-BD31-4B8C-83A1-F6EECF244321}">
                <p14:modId xmlns:p14="http://schemas.microsoft.com/office/powerpoint/2010/main" val="3180102365"/>
              </p:ext>
            </p:extLst>
          </p:nvPr>
        </p:nvGraphicFramePr>
        <p:xfrm>
          <a:off x="3123269" y="461572"/>
          <a:ext cx="6843689" cy="5934855"/>
        </p:xfrm>
        <a:graphic>
          <a:graphicData uri="http://schemas.openxmlformats.org/drawingml/2006/table">
            <a:tbl>
              <a:tblPr>
                <a:noFill/>
              </a:tblPr>
              <a:tblGrid>
                <a:gridCol w="31183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6265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62655">
                  <a:extLst>
                    <a:ext uri="{9D8B030D-6E8A-4147-A177-3AD203B41FA5}">
                      <a16:colId xmlns:a16="http://schemas.microsoft.com/office/drawing/2014/main" val="1464859320"/>
                    </a:ext>
                  </a:extLst>
                </a:gridCol>
              </a:tblGrid>
              <a:tr h="463002">
                <a:tc gridSpan="3"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dirty="0">
                          <a:latin typeface="+mn-lt"/>
                        </a:rPr>
                        <a:t>Complete Blood Count</a:t>
                      </a:r>
                      <a:endParaRPr sz="2000" b="1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hMerge="1"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hMerge="1"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2000" b="1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1632793"/>
                  </a:ext>
                </a:extLst>
              </a:tr>
              <a:tr h="463002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2000" b="1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Normal Value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5773484"/>
                  </a:ext>
                </a:extLst>
              </a:tr>
              <a:tr h="463002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dirty="0">
                          <a:latin typeface="+mn-lt"/>
                        </a:rPr>
                        <a:t>WBC</a:t>
                      </a:r>
                      <a:endParaRPr sz="2000" b="1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25.3 </a:t>
                      </a:r>
                      <a:r>
                        <a:rPr lang="en-US" sz="2000" b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x 10</a:t>
                      </a:r>
                      <a:r>
                        <a:rPr lang="en-US" sz="2000" b="0" baseline="30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US" sz="2000" b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/L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4.3-10.8</a:t>
                      </a:r>
                      <a:r>
                        <a:rPr lang="en-US" sz="2000" b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x 10</a:t>
                      </a:r>
                      <a:r>
                        <a:rPr lang="en-US" sz="2000" b="0" baseline="30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US" sz="2000" b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/L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63002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dirty="0">
                          <a:latin typeface="+mn-lt"/>
                        </a:rPr>
                        <a:t>Hemoglobin</a:t>
                      </a:r>
                      <a:endParaRPr sz="2000" b="1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8.2 </a:t>
                      </a:r>
                      <a:r>
                        <a:rPr lang="en-US" sz="2000" b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/dL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120-160 g/dL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63002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>
                          <a:latin typeface="+mn-lt"/>
                        </a:rPr>
                        <a:t>Hematocrit</a:t>
                      </a:r>
                      <a:endParaRPr sz="2000" b="1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24.6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37-48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63002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>
                          <a:latin typeface="+mn-lt"/>
                        </a:rPr>
                        <a:t>MCV</a:t>
                      </a:r>
                      <a:endParaRPr sz="2000" b="1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85 </a:t>
                      </a:r>
                      <a:r>
                        <a:rPr lang="en-US" sz="2000" b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µm</a:t>
                      </a:r>
                      <a:r>
                        <a:rPr lang="en-US" sz="2000" b="0" baseline="30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80-100 </a:t>
                      </a:r>
                      <a:r>
                        <a:rPr lang="en-US" sz="2000" b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µm</a:t>
                      </a:r>
                      <a:r>
                        <a:rPr lang="en-US" sz="2000" b="0" baseline="30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63002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dirty="0">
                          <a:latin typeface="+mn-lt"/>
                        </a:rPr>
                        <a:t>Platelet</a:t>
                      </a:r>
                      <a:endParaRPr sz="2000" b="1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300 </a:t>
                      </a:r>
                      <a:r>
                        <a:rPr lang="en-US" sz="2000" b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x 10</a:t>
                      </a:r>
                      <a:r>
                        <a:rPr lang="en-US" sz="2000" b="0" baseline="30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US" sz="2000" b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/L</a:t>
                      </a:r>
                      <a:endParaRPr lang="en-US" sz="20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0-450 </a:t>
                      </a:r>
                      <a:r>
                        <a:rPr lang="en-US" sz="2000" b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sz="2000" b="0" baseline="300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r>
                        <a:rPr lang="en-US" sz="2000" b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/L</a:t>
                      </a:r>
                      <a:endParaRPr lang="en-US" sz="2000" b="0" dirty="0">
                        <a:solidFill>
                          <a:schemeClr val="tx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841833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dirty="0">
                          <a:latin typeface="+mn-lt"/>
                        </a:rPr>
                        <a:t>Segmented Neutrophils</a:t>
                      </a:r>
                      <a:endParaRPr sz="2000" b="1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90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54-65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63002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>
                          <a:latin typeface="+mn-lt"/>
                        </a:rPr>
                        <a:t>Lymphocytes</a:t>
                      </a:r>
                      <a:endParaRPr sz="2000" b="1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5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25-40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63002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>
                          <a:latin typeface="+mn-lt"/>
                        </a:rPr>
                        <a:t>Monocytes</a:t>
                      </a:r>
                      <a:endParaRPr sz="2000" b="1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>
                          <a:solidFill>
                            <a:schemeClr val="tx1"/>
                          </a:solidFill>
                          <a:latin typeface="+mn-lt"/>
                        </a:rPr>
                        <a:t>4</a:t>
                      </a:r>
                      <a:endParaRPr sz="2000" b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2-8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63002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>
                          <a:latin typeface="+mn-lt"/>
                        </a:rPr>
                        <a:t>Eosinophils</a:t>
                      </a:r>
                      <a:endParaRPr sz="2000" b="1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1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1-4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63002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>
                          <a:latin typeface="+mn-lt"/>
                        </a:rPr>
                        <a:t>Basophils</a:t>
                      </a:r>
                      <a:endParaRPr sz="2000" b="1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0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  <a:latin typeface="+mn-lt"/>
                        </a:rPr>
                        <a:t>0-1</a:t>
                      </a:r>
                      <a:endParaRPr sz="2000" b="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0" name="Google Shape;110;g11b19981c3f_1_1"/>
          <p:cNvGraphicFramePr/>
          <p:nvPr>
            <p:extLst>
              <p:ext uri="{D42A27DB-BD31-4B8C-83A1-F6EECF244321}">
                <p14:modId xmlns:p14="http://schemas.microsoft.com/office/powerpoint/2010/main" val="1807135423"/>
              </p:ext>
            </p:extLst>
          </p:nvPr>
        </p:nvGraphicFramePr>
        <p:xfrm>
          <a:off x="2774760" y="2423766"/>
          <a:ext cx="6631774" cy="368046"/>
        </p:xfrm>
        <a:graphic>
          <a:graphicData uri="http://schemas.openxmlformats.org/drawingml/2006/table">
            <a:tbl>
              <a:tblPr>
                <a:noFill/>
              </a:tblPr>
              <a:tblGrid>
                <a:gridCol w="302181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0497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804978">
                  <a:extLst>
                    <a:ext uri="{9D8B030D-6E8A-4147-A177-3AD203B41FA5}">
                      <a16:colId xmlns:a16="http://schemas.microsoft.com/office/drawing/2014/main" val="717388022"/>
                    </a:ext>
                  </a:extLst>
                </a:gridCol>
              </a:tblGrid>
              <a:tr h="36636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dirty="0"/>
                        <a:t>Reticulocyte count</a:t>
                      </a:r>
                      <a:endParaRPr sz="2000" b="1" dirty="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</a:rPr>
                        <a:t>9%</a:t>
                      </a:r>
                      <a:endParaRPr sz="2000" b="0" dirty="0">
                        <a:solidFill>
                          <a:schemeClr val="tx1"/>
                        </a:solidFill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</a:rPr>
                        <a:t>Normal 0.5-2.5%</a:t>
                      </a:r>
                      <a:endParaRPr sz="2000" b="0" dirty="0">
                        <a:solidFill>
                          <a:schemeClr val="tx1"/>
                        </a:solidFill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112" name="Google Shape;112;g11b19981c3f_1_1"/>
          <p:cNvGraphicFramePr/>
          <p:nvPr>
            <p:extLst>
              <p:ext uri="{D42A27DB-BD31-4B8C-83A1-F6EECF244321}">
                <p14:modId xmlns:p14="http://schemas.microsoft.com/office/powerpoint/2010/main" val="3341933912"/>
              </p:ext>
            </p:extLst>
          </p:nvPr>
        </p:nvGraphicFramePr>
        <p:xfrm>
          <a:off x="3394542" y="3845718"/>
          <a:ext cx="5392211" cy="448370"/>
        </p:xfrm>
        <a:graphic>
          <a:graphicData uri="http://schemas.openxmlformats.org/drawingml/2006/table">
            <a:tbl>
              <a:tblPr>
                <a:noFill/>
              </a:tblPr>
              <a:tblGrid>
                <a:gridCol w="337580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1640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448370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dirty="0"/>
                        <a:t>Coronavirus Rapid Test</a:t>
                      </a:r>
                      <a:endParaRPr sz="2000" b="1" dirty="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/>
                        <a:t>Not Detected</a:t>
                      </a:r>
                      <a:endParaRPr sz="2000" b="0" dirty="0"/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8" name="Google Shape;118;g123e9aacdc9_0_28"/>
          <p:cNvGraphicFramePr/>
          <p:nvPr>
            <p:extLst>
              <p:ext uri="{D42A27DB-BD31-4B8C-83A1-F6EECF244321}">
                <p14:modId xmlns:p14="http://schemas.microsoft.com/office/powerpoint/2010/main" val="2822246877"/>
              </p:ext>
            </p:extLst>
          </p:nvPr>
        </p:nvGraphicFramePr>
        <p:xfrm>
          <a:off x="2492669" y="229497"/>
          <a:ext cx="7206662" cy="6399006"/>
        </p:xfrm>
        <a:graphic>
          <a:graphicData uri="http://schemas.openxmlformats.org/drawingml/2006/table">
            <a:tbl>
              <a:tblPr>
                <a:noFill/>
              </a:tblPr>
              <a:tblGrid>
                <a:gridCol w="328376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6144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961448">
                  <a:extLst>
                    <a:ext uri="{9D8B030D-6E8A-4147-A177-3AD203B41FA5}">
                      <a16:colId xmlns:a16="http://schemas.microsoft.com/office/drawing/2014/main" val="2158508397"/>
                    </a:ext>
                  </a:extLst>
                </a:gridCol>
              </a:tblGrid>
              <a:tr h="376375">
                <a:tc gridSpan="3"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dirty="0">
                          <a:latin typeface="+mn-lt"/>
                        </a:rPr>
                        <a:t>Complete Metabolic Panel</a:t>
                      </a:r>
                      <a:endParaRPr sz="2000" b="1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hMerge="1"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hMerge="1">
                  <a:txBody>
                    <a:bodyPr/>
                    <a:lstStyle/>
                    <a:p>
                      <a:pPr marL="0" lvl="0" indent="0" algn="ctr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2000" b="1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4752726"/>
                  </a:ext>
                </a:extLst>
              </a:tr>
              <a:tr h="3763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2000" b="1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Normal Values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1466493"/>
                  </a:ext>
                </a:extLst>
              </a:tr>
              <a:tr h="3763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dirty="0">
                          <a:latin typeface="+mn-lt"/>
                        </a:rPr>
                        <a:t>Sodium</a:t>
                      </a:r>
                      <a:endParaRPr sz="2000" b="1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141 </a:t>
                      </a:r>
                      <a:r>
                        <a:rPr lang="en-US" sz="2000" b="0" dirty="0"/>
                        <a:t>mmol/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/>
                        <a:t>136—145 mmol/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63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>
                          <a:latin typeface="+mn-lt"/>
                        </a:rPr>
                        <a:t>Potassium </a:t>
                      </a:r>
                      <a:endParaRPr sz="2000" b="1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3.7 </a:t>
                      </a:r>
                      <a:r>
                        <a:rPr lang="en-US" sz="2000" b="0" dirty="0"/>
                        <a:t>mmol/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/>
                        <a:t>3.5—5.0 mmol/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63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>
                          <a:latin typeface="+mn-lt"/>
                        </a:rPr>
                        <a:t>Chloride</a:t>
                      </a:r>
                      <a:endParaRPr sz="2000" b="1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106 </a:t>
                      </a:r>
                      <a:r>
                        <a:rPr lang="en-US" sz="2000" b="0" dirty="0"/>
                        <a:t>mmol/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/>
                        <a:t>98 – 110 mmol/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7006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>
                          <a:latin typeface="+mn-lt"/>
                        </a:rPr>
                        <a:t>CO2</a:t>
                      </a:r>
                      <a:endParaRPr sz="2000" b="1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23 </a:t>
                      </a:r>
                      <a:r>
                        <a:rPr lang="en-US" sz="2000" b="0" dirty="0"/>
                        <a:t>mmol/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/>
                        <a:t>24 – 32 mmol/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63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dirty="0">
                          <a:latin typeface="+mn-lt"/>
                        </a:rPr>
                        <a:t>Creatinine</a:t>
                      </a:r>
                      <a:endParaRPr sz="2000" b="1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0.57 </a:t>
                      </a:r>
                      <a:r>
                        <a:rPr lang="en-US" sz="2000" b="0" dirty="0"/>
                        <a:t>mmol/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/>
                        <a:t>0.59 – 1.04 mg/dL</a:t>
                      </a:r>
                    </a:p>
                  </a:txBody>
                  <a:tcPr marL="28575" marR="28575" marT="19050" marB="19050" anchor="b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763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dirty="0">
                          <a:latin typeface="+mn-lt"/>
                        </a:rPr>
                        <a:t>BUN</a:t>
                      </a:r>
                      <a:endParaRPr sz="2000" b="1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20 </a:t>
                      </a:r>
                      <a:r>
                        <a:rPr lang="en-US" sz="2000" b="0" dirty="0"/>
                        <a:t>mg/d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5 – 25 </a:t>
                      </a:r>
                      <a:r>
                        <a:rPr lang="en-US" sz="2000" b="0" dirty="0"/>
                        <a:t>mg/d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763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>
                          <a:latin typeface="+mn-lt"/>
                        </a:rPr>
                        <a:t>Glucose</a:t>
                      </a:r>
                      <a:endParaRPr sz="2000" b="1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90 </a:t>
                      </a:r>
                      <a:r>
                        <a:rPr lang="en-US" sz="2000" b="0" dirty="0"/>
                        <a:t>mg/d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70 – </a:t>
                      </a:r>
                      <a:r>
                        <a:rPr lang="en-US" sz="2000" b="0" dirty="0"/>
                        <a:t>100 mg/d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763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>
                          <a:latin typeface="+mn-lt"/>
                        </a:rPr>
                        <a:t>Calcium</a:t>
                      </a:r>
                      <a:endParaRPr sz="2000" b="1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8.9 </a:t>
                      </a:r>
                      <a:r>
                        <a:rPr lang="en-US" sz="2000" b="0" dirty="0"/>
                        <a:t>mg/d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/>
                        <a:t>8.5 –10.5 mg/d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763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>
                          <a:latin typeface="+mn-lt"/>
                        </a:rPr>
                        <a:t>Protein Total</a:t>
                      </a:r>
                      <a:endParaRPr sz="2000" b="1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7.2 </a:t>
                      </a:r>
                      <a:r>
                        <a:rPr lang="en-US" sz="2000" b="0" dirty="0"/>
                        <a:t>mg/d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/>
                        <a:t>6.0 – 8.0 g/d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763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>
                          <a:latin typeface="+mn-lt"/>
                        </a:rPr>
                        <a:t>Albumin</a:t>
                      </a:r>
                      <a:endParaRPr sz="2000" b="1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3.5 </a:t>
                      </a:r>
                      <a:r>
                        <a:rPr lang="en-US" sz="2000" b="0" dirty="0"/>
                        <a:t>mg/d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/>
                        <a:t>3.2 – 5.5 g/d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763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dirty="0">
                          <a:latin typeface="+mn-lt"/>
                        </a:rPr>
                        <a:t>ALT</a:t>
                      </a:r>
                      <a:endParaRPr sz="2000" b="1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28 </a:t>
                      </a:r>
                      <a:r>
                        <a:rPr lang="en-US" sz="2000" b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nits/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/>
                        <a:t>7—30 units/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763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>
                          <a:latin typeface="+mn-lt"/>
                        </a:rPr>
                        <a:t>AST</a:t>
                      </a:r>
                      <a:endParaRPr sz="2000" b="1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35 </a:t>
                      </a:r>
                      <a:r>
                        <a:rPr lang="en-US" sz="2000" b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nits/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/>
                        <a:t>9—25 units/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3763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>
                          <a:latin typeface="+mn-lt"/>
                        </a:rPr>
                        <a:t>Alk Phos</a:t>
                      </a:r>
                      <a:endParaRPr sz="2000" b="1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CCCCCC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293 </a:t>
                      </a:r>
                      <a:r>
                        <a:rPr lang="en-US" sz="2000" b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units/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pl-PL" sz="2000" dirty="0"/>
                        <a:t>14</a:t>
                      </a:r>
                      <a:r>
                        <a:rPr lang="en-US" sz="2000" dirty="0"/>
                        <a:t> – </a:t>
                      </a:r>
                      <a:r>
                        <a:rPr lang="pl-PL" sz="2000" dirty="0"/>
                        <a:t>27 </a:t>
                      </a:r>
                      <a:r>
                        <a:rPr lang="en-US" sz="2000" dirty="0"/>
                        <a:t>units</a:t>
                      </a:r>
                      <a:r>
                        <a:rPr lang="pl-PL" sz="2000" dirty="0"/>
                        <a:t>/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3763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>
                          <a:latin typeface="+mn-lt"/>
                        </a:rPr>
                        <a:t>Bilirubin Total</a:t>
                      </a:r>
                      <a:endParaRPr sz="2000" b="1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0.4 </a:t>
                      </a:r>
                      <a:r>
                        <a:rPr lang="en-US" sz="2000" b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g/d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dirty="0"/>
                        <a:t>0.3—1.0 mg/d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37637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dirty="0">
                          <a:latin typeface="+mn-lt"/>
                        </a:rPr>
                        <a:t>Bilirubin Direct</a:t>
                      </a:r>
                      <a:endParaRPr sz="2000" b="1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latin typeface="+mn-lt"/>
                        </a:rPr>
                        <a:t>&lt;0.1 </a:t>
                      </a:r>
                      <a:r>
                        <a:rPr lang="en-US" sz="2000" b="0" dirty="0">
                          <a:solidFill>
                            <a:srgbClr val="000000"/>
                          </a:solidFill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g/d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dirty="0"/>
                        <a:t>0.1—0.3 mg/dL</a:t>
                      </a:r>
                      <a:endParaRPr sz="2000" b="0" dirty="0">
                        <a:latin typeface="+mn-lt"/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oogle Shape;111;g11b19981c3f_1_1">
            <a:extLst>
              <a:ext uri="{FF2B5EF4-FFF2-40B4-BE49-F238E27FC236}">
                <a16:creationId xmlns:a16="http://schemas.microsoft.com/office/drawing/2014/main" id="{0836C65C-DB98-1442-5959-ABD146E46FB1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75519295"/>
              </p:ext>
            </p:extLst>
          </p:nvPr>
        </p:nvGraphicFramePr>
        <p:xfrm>
          <a:off x="1860884" y="2351898"/>
          <a:ext cx="8951494" cy="368046"/>
        </p:xfrm>
        <a:graphic>
          <a:graphicData uri="http://schemas.openxmlformats.org/drawingml/2006/table">
            <a:tbl>
              <a:tblPr>
                <a:noFill/>
              </a:tblPr>
              <a:tblGrid>
                <a:gridCol w="407882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43633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36333">
                  <a:extLst>
                    <a:ext uri="{9D8B030D-6E8A-4147-A177-3AD203B41FA5}">
                      <a16:colId xmlns:a16="http://schemas.microsoft.com/office/drawing/2014/main" val="3212193559"/>
                    </a:ext>
                  </a:extLst>
                </a:gridCol>
              </a:tblGrid>
              <a:tr h="36636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dirty="0">
                          <a:solidFill>
                            <a:schemeClr val="tx1"/>
                          </a:solidFill>
                        </a:rPr>
                        <a:t>Erythrocyte Sedimentation Rate</a:t>
                      </a:r>
                      <a:endParaRPr sz="2000" b="1" dirty="0">
                        <a:solidFill>
                          <a:schemeClr val="tx1"/>
                        </a:solidFill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</a:rPr>
                        <a:t> 105 mm/h</a:t>
                      </a:r>
                      <a:endParaRPr sz="2000" b="0" dirty="0">
                        <a:solidFill>
                          <a:schemeClr val="tx1"/>
                        </a:solidFill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</a:rPr>
                        <a:t>Normal 0-29 mm/h</a:t>
                      </a:r>
                      <a:endParaRPr sz="2000" b="0" dirty="0">
                        <a:solidFill>
                          <a:schemeClr val="tx1"/>
                        </a:solidFill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5" name="Google Shape;111;g11b19981c3f_1_1">
            <a:extLst>
              <a:ext uri="{FF2B5EF4-FFF2-40B4-BE49-F238E27FC236}">
                <a16:creationId xmlns:a16="http://schemas.microsoft.com/office/drawing/2014/main" id="{5BBCEAEB-2C8C-508C-3252-4B17C3A4988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590422499"/>
              </p:ext>
            </p:extLst>
          </p:nvPr>
        </p:nvGraphicFramePr>
        <p:xfrm>
          <a:off x="2244086" y="3954034"/>
          <a:ext cx="8185089" cy="368046"/>
        </p:xfrm>
        <a:graphic>
          <a:graphicData uri="http://schemas.openxmlformats.org/drawingml/2006/table">
            <a:tbl>
              <a:tblPr>
                <a:noFill/>
              </a:tblPr>
              <a:tblGrid>
                <a:gridCol w="372960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22774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227740">
                  <a:extLst>
                    <a:ext uri="{9D8B030D-6E8A-4147-A177-3AD203B41FA5}">
                      <a16:colId xmlns:a16="http://schemas.microsoft.com/office/drawing/2014/main" val="2117643002"/>
                    </a:ext>
                  </a:extLst>
                </a:gridCol>
              </a:tblGrid>
              <a:tr h="366365"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1" dirty="0">
                          <a:solidFill>
                            <a:schemeClr val="tx1"/>
                          </a:solidFill>
                        </a:rPr>
                        <a:t>C Reactive protein</a:t>
                      </a:r>
                      <a:endParaRPr sz="2000" b="1" dirty="0">
                        <a:solidFill>
                          <a:schemeClr val="tx1"/>
                        </a:solidFill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</a:rPr>
                        <a:t>22 mg/dL</a:t>
                      </a:r>
                      <a:endParaRPr sz="2000" b="0" dirty="0">
                        <a:solidFill>
                          <a:schemeClr val="tx1"/>
                        </a:solidFill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lvl="0" indent="0" algn="l" rtl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2000" b="0" dirty="0">
                          <a:solidFill>
                            <a:schemeClr val="tx1"/>
                          </a:solidFill>
                        </a:rPr>
                        <a:t>Normal &lt;0.3 mg/dL</a:t>
                      </a:r>
                      <a:endParaRPr sz="2000" b="0" dirty="0">
                        <a:solidFill>
                          <a:schemeClr val="tx1"/>
                        </a:solidFill>
                      </a:endParaRPr>
                    </a:p>
                  </a:txBody>
                  <a:tcPr marL="28575" marR="28575" marT="19050" marB="19050" anchor="b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671692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AF82D8D-4C3F-364C-B094-53101DA1FD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4099037"/>
              </p:ext>
            </p:extLst>
          </p:nvPr>
        </p:nvGraphicFramePr>
        <p:xfrm>
          <a:off x="2017667" y="990600"/>
          <a:ext cx="8156666" cy="4876800"/>
        </p:xfrm>
        <a:graphic>
          <a:graphicData uri="http://schemas.openxmlformats.org/drawingml/2006/table">
            <a:tbl>
              <a:tblPr firstRow="1" firstCol="1" bandRow="1"/>
              <a:tblGrid>
                <a:gridCol w="2903594">
                  <a:extLst>
                    <a:ext uri="{9D8B030D-6E8A-4147-A177-3AD203B41FA5}">
                      <a16:colId xmlns:a16="http://schemas.microsoft.com/office/drawing/2014/main" val="310790649"/>
                    </a:ext>
                  </a:extLst>
                </a:gridCol>
                <a:gridCol w="2626536">
                  <a:extLst>
                    <a:ext uri="{9D8B030D-6E8A-4147-A177-3AD203B41FA5}">
                      <a16:colId xmlns:a16="http://schemas.microsoft.com/office/drawing/2014/main" val="3351051785"/>
                    </a:ext>
                  </a:extLst>
                </a:gridCol>
                <a:gridCol w="2626536">
                  <a:extLst>
                    <a:ext uri="{9D8B030D-6E8A-4147-A177-3AD203B41FA5}">
                      <a16:colId xmlns:a16="http://schemas.microsoft.com/office/drawing/2014/main" val="3836440062"/>
                    </a:ext>
                  </a:extLst>
                </a:gridCol>
              </a:tblGrid>
              <a:tr h="201930">
                <a:tc gridSpan="3">
                  <a:txBody>
                    <a:bodyPr/>
                    <a:lstStyle/>
                    <a:p>
                      <a:pPr marL="0" marR="0" algn="ctr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b="1" dirty="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Urinalysis (UA)</a:t>
                      </a:r>
                      <a:endParaRPr lang="en-US" sz="20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0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36476419"/>
                  </a:ext>
                </a:extLst>
              </a:tr>
              <a:tr h="194945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0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ormal Values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550035"/>
                  </a:ext>
                </a:extLst>
              </a:tr>
              <a:tr h="194945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Color</a:t>
                      </a: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Yellow</a:t>
                      </a:r>
                      <a:endParaRPr lang="en-US" sz="20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Yellow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36025171"/>
                  </a:ext>
                </a:extLst>
              </a:tr>
              <a:tr h="201930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Appearance</a:t>
                      </a: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Clear</a:t>
                      </a: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lear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1036183"/>
                  </a:ext>
                </a:extLst>
              </a:tr>
              <a:tr h="194945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Specific Gravity</a:t>
                      </a: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1.050</a:t>
                      </a:r>
                      <a:endParaRPr lang="en-US" sz="20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/>
                        <a:t>1.005-1.025</a:t>
                      </a:r>
                      <a:endParaRPr lang="en-US" sz="20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6579442"/>
                  </a:ext>
                </a:extLst>
              </a:tr>
              <a:tr h="201930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pH</a:t>
                      </a: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7.4</a:t>
                      </a:r>
                      <a:endParaRPr lang="en-US" sz="20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5-8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5858070"/>
                  </a:ext>
                </a:extLst>
              </a:tr>
              <a:tr h="201930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Glucose</a:t>
                      </a: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Negative</a:t>
                      </a: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gativ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8321823"/>
                  </a:ext>
                </a:extLst>
              </a:tr>
              <a:tr h="194945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Bilirubin</a:t>
                      </a: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Negative</a:t>
                      </a: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egative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6654296"/>
                  </a:ext>
                </a:extLst>
              </a:tr>
              <a:tr h="201930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Ketones</a:t>
                      </a: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0</a:t>
                      </a: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85622109"/>
                  </a:ext>
                </a:extLst>
              </a:tr>
              <a:tr h="194945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Protein</a:t>
                      </a: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2+</a:t>
                      </a:r>
                      <a:endParaRPr lang="en-US" sz="20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9176302"/>
                  </a:ext>
                </a:extLst>
              </a:tr>
              <a:tr h="201930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Leukocyte esterase</a:t>
                      </a: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1+</a:t>
                      </a:r>
                      <a:endParaRPr lang="en-US" sz="20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5714890"/>
                  </a:ext>
                </a:extLst>
              </a:tr>
              <a:tr h="201930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Nitrites</a:t>
                      </a:r>
                      <a:endParaRPr lang="en-US" sz="20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Negative</a:t>
                      </a:r>
                      <a:endParaRPr lang="en-US" sz="20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3617755"/>
                  </a:ext>
                </a:extLst>
              </a:tr>
              <a:tr h="194945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White blood cells (WBC)</a:t>
                      </a: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1 WBCs/high powered field (HPF)</a:t>
                      </a:r>
                      <a:endParaRPr lang="en-US" sz="20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8486332"/>
                  </a:ext>
                </a:extLst>
              </a:tr>
              <a:tr h="201930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Red blood cells (RBC)</a:t>
                      </a: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0 RBCs/HPF</a:t>
                      </a:r>
                      <a:endParaRPr lang="en-US" sz="20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2977649"/>
                  </a:ext>
                </a:extLst>
              </a:tr>
              <a:tr h="201930"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Squamous epithelial cells</a:t>
                      </a:r>
                      <a:endParaRPr lang="en-US" sz="200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MS Mincho" panose="02020609040205080304" pitchFamily="49" charset="-128"/>
                          <a:cs typeface="Times New Roman" panose="02020603050405020304" pitchFamily="18" charset="0"/>
                        </a:rPr>
                        <a:t>0-5 cells/HPF</a:t>
                      </a:r>
                      <a:endParaRPr lang="en-US" sz="200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fontAlgn="base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00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3415144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Google Shape;130;g123e9aacdc9_0_42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700"/>
          </a:xfrm>
          <a:prstGeom prst="rect">
            <a:avLst/>
          </a:prstGeom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Elbow X-ray</a:t>
            </a:r>
            <a:endParaRPr/>
          </a:p>
        </p:txBody>
      </p:sp>
      <p:sp>
        <p:nvSpPr>
          <p:cNvPr id="131" name="Google Shape;131;g123e9aacdc9_0_42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2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spcBef>
                <a:spcPts val="1000"/>
              </a:spcBef>
              <a:spcAft>
                <a:spcPts val="0"/>
              </a:spcAft>
              <a:buNone/>
            </a:pPr>
            <a:r>
              <a:rPr lang="en-US" dirty="0"/>
              <a:t>IMPRESSION:</a:t>
            </a:r>
            <a:endParaRPr dirty="0"/>
          </a:p>
          <a:p>
            <a:pPr marL="0" lvl="0" indent="0" algn="l" rtl="0">
              <a:spcBef>
                <a:spcPts val="1000"/>
              </a:spcBef>
              <a:spcAft>
                <a:spcPts val="0"/>
              </a:spcAft>
              <a:buNone/>
            </a:pPr>
            <a:r>
              <a:rPr lang="en-US" dirty="0"/>
              <a:t>No fracture or abnormality noted. Mild soft tissue swelling about the elbow, but no joint space widening. If you suspect osteomyelitis clinically, consider MRI imaging of the affected area.</a:t>
            </a:r>
            <a:endParaRPr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651</Words>
  <Application>Microsoft Office PowerPoint</Application>
  <PresentationFormat>Widescreen</PresentationFormat>
  <Paragraphs>156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Chief Complain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Elbow X-ray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hief Complaint</dc:title>
  <dc:creator>Adeola Kosoko</dc:creator>
  <cp:lastModifiedBy>Adeola Kosoko</cp:lastModifiedBy>
  <cp:revision>6</cp:revision>
  <dcterms:created xsi:type="dcterms:W3CDTF">2022-08-24T16:18:27Z</dcterms:created>
  <dcterms:modified xsi:type="dcterms:W3CDTF">2023-01-18T07:38:30Z</dcterms:modified>
</cp:coreProperties>
</file>